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431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2160"/>
        <p:guide pos="43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0D735-413C-4A80-8055-2BD3B0449C3E}" type="datetimeFigureOut">
              <a:rPr lang="he-IL" smtClean="0"/>
              <a:t>כ"א/אלול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1C4-27F8-4DE9-82B4-FCD5985938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29345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0D735-413C-4A80-8055-2BD3B0449C3E}" type="datetimeFigureOut">
              <a:rPr lang="he-IL" smtClean="0"/>
              <a:t>כ"א/אלול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1C4-27F8-4DE9-82B4-FCD5985938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37075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0D735-413C-4A80-8055-2BD3B0449C3E}" type="datetimeFigureOut">
              <a:rPr lang="he-IL" smtClean="0"/>
              <a:t>כ"א/אלול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1C4-27F8-4DE9-82B4-FCD5985938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62590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0D735-413C-4A80-8055-2BD3B0449C3E}" type="datetimeFigureOut">
              <a:rPr lang="he-IL" smtClean="0"/>
              <a:t>כ"א/אלול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1C4-27F8-4DE9-82B4-FCD5985938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73984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0D735-413C-4A80-8055-2BD3B0449C3E}" type="datetimeFigureOut">
              <a:rPr lang="he-IL" smtClean="0"/>
              <a:t>כ"א/אלול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1C4-27F8-4DE9-82B4-FCD5985938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35450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0D735-413C-4A80-8055-2BD3B0449C3E}" type="datetimeFigureOut">
              <a:rPr lang="he-IL" smtClean="0"/>
              <a:t>כ"א/אלול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1C4-27F8-4DE9-82B4-FCD5985938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97364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0D735-413C-4A80-8055-2BD3B0449C3E}" type="datetimeFigureOut">
              <a:rPr lang="he-IL" smtClean="0"/>
              <a:t>כ"א/אלול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1C4-27F8-4DE9-82B4-FCD5985938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94855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0D735-413C-4A80-8055-2BD3B0449C3E}" type="datetimeFigureOut">
              <a:rPr lang="he-IL" smtClean="0"/>
              <a:t>כ"א/אלול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1C4-27F8-4DE9-82B4-FCD5985938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38457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0D735-413C-4A80-8055-2BD3B0449C3E}" type="datetimeFigureOut">
              <a:rPr lang="he-IL" smtClean="0"/>
              <a:t>כ"א/אלול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1C4-27F8-4DE9-82B4-FCD5985938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56264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0D735-413C-4A80-8055-2BD3B0449C3E}" type="datetimeFigureOut">
              <a:rPr lang="he-IL" smtClean="0"/>
              <a:t>כ"א/אלול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1C4-27F8-4DE9-82B4-FCD5985938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25727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A0D735-413C-4A80-8055-2BD3B0449C3E}" type="datetimeFigureOut">
              <a:rPr lang="he-IL" smtClean="0"/>
              <a:t>כ"א/אלול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B91C4-27F8-4DE9-82B4-FCD5985938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21049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A0D735-413C-4A80-8055-2BD3B0449C3E}" type="datetimeFigureOut">
              <a:rPr lang="he-IL" smtClean="0"/>
              <a:t>כ"א/אלול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5B91C4-27F8-4DE9-82B4-FCD5985938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29074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8699" y="3429000"/>
            <a:ext cx="3029660" cy="302966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13958" y="97772"/>
            <a:ext cx="3094317" cy="302966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37445" y="97772"/>
            <a:ext cx="3094317" cy="302966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86618" y="3429000"/>
            <a:ext cx="3029660" cy="3029660"/>
          </a:xfrm>
          <a:prstGeom prst="rect">
            <a:avLst/>
          </a:prstGeom>
        </p:spPr>
      </p:pic>
      <p:sp>
        <p:nvSpPr>
          <p:cNvPr id="21" name="מלבן 3"/>
          <p:cNvSpPr/>
          <p:nvPr/>
        </p:nvSpPr>
        <p:spPr>
          <a:xfrm>
            <a:off x="9760932" y="97772"/>
            <a:ext cx="2380755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+mj-cs"/>
              </a:rPr>
              <a:t>Supplementary </a:t>
            </a:r>
            <a:r>
              <a:rPr lang="en-US" sz="1200" b="1" dirty="0" smtClean="0">
                <a:latin typeface="Times New Roman" panose="02020603050405020304" pitchFamily="18" charset="0"/>
                <a:cs typeface="+mj-cs"/>
              </a:rPr>
              <a:t>Figure 1. </a:t>
            </a:r>
            <a:r>
              <a:rPr lang="en-GB" sz="1200" b="1" dirty="0" smtClean="0">
                <a:latin typeface="Times New Roman" panose="02020603050405020304" pitchFamily="18" charset="0"/>
                <a:cs typeface="+mj-cs"/>
              </a:rPr>
              <a:t>Gating strategy of TIL transduction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gated 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able (FSC vs SS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ingle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. Transductio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ga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ording to the un-transduced cells (UT) stained with Fab+ vs. CD3+ cells.  </a:t>
            </a:r>
            <a:r>
              <a:rPr lang="en-GB" sz="1200" dirty="0" smtClean="0">
                <a:latin typeface="Times New Roman" panose="02020603050405020304" pitchFamily="18" charset="0"/>
              </a:rPr>
              <a:t> Example shown </a:t>
            </a:r>
            <a:r>
              <a:rPr lang="en-GB" sz="1200" dirty="0" smtClean="0">
                <a:latin typeface="Times New Roman" panose="02020603050405020304" pitchFamily="18" charset="0"/>
                <a:cs typeface="+mj-cs"/>
              </a:rPr>
              <a:t>for TIL 014. </a:t>
            </a:r>
            <a:endParaRPr lang="en-US" sz="1200" dirty="0">
              <a:latin typeface="Times New Roman" panose="02020603050405020304" pitchFamily="18" charset="0"/>
              <a:cs typeface="+mj-cs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229233" y="3348837"/>
            <a:ext cx="2359126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  <a:endParaRPr lang="he-IL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851650" y="3348836"/>
            <a:ext cx="2364627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 rtl="0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D</a:t>
            </a:r>
            <a:endParaRPr lang="he-IL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5791200" y="1612602"/>
            <a:ext cx="304800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6096000" y="2843304"/>
            <a:ext cx="0" cy="542748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81196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53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heb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יצחקי אורית, דר</cp:lastModifiedBy>
  <cp:revision>8</cp:revision>
  <dcterms:created xsi:type="dcterms:W3CDTF">2020-08-18T13:29:08Z</dcterms:created>
  <dcterms:modified xsi:type="dcterms:W3CDTF">2020-09-10T06:52:28Z</dcterms:modified>
</cp:coreProperties>
</file>